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3" userDrawn="1">
          <p15:clr>
            <a:srgbClr val="A4A3A4"/>
          </p15:clr>
        </p15:guide>
        <p15:guide id="2" pos="249" userDrawn="1">
          <p15:clr>
            <a:srgbClr val="A4A3A4"/>
          </p15:clr>
        </p15:guide>
        <p15:guide id="3" orient="horz" pos="37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33" y="82"/>
      </p:cViewPr>
      <p:guideLst>
        <p:guide orient="horz" pos="2523"/>
        <p:guide pos="249"/>
        <p:guide orient="horz" pos="37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140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9566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4638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802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895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0054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546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7423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7769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0982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8564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B9FE3-CCC4-4B33-B5F3-6AED809FBD13}" type="datetimeFigureOut">
              <a:rPr lang="de-DE" smtClean="0"/>
              <a:t>20.05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094FC-9433-4071-8B4A-997B72271EA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7520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hteck 21"/>
          <p:cNvSpPr/>
          <p:nvPr/>
        </p:nvSpPr>
        <p:spPr>
          <a:xfrm>
            <a:off x="179512" y="187500"/>
            <a:ext cx="8575002" cy="446563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de-DE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endParaRPr lang="de-DE" dirty="0"/>
          </a:p>
        </p:txBody>
      </p:sp>
      <p:sp>
        <p:nvSpPr>
          <p:cNvPr id="2" name="Textfeld 1"/>
          <p:cNvSpPr txBox="1"/>
          <p:nvPr/>
        </p:nvSpPr>
        <p:spPr>
          <a:xfrm>
            <a:off x="395288" y="4072231"/>
            <a:ext cx="2940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L</a:t>
            </a:r>
            <a:endParaRPr lang="de-DE" sz="20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8387019" y="4072231"/>
            <a:ext cx="2940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R</a:t>
            </a:r>
            <a:endParaRPr lang="de-DE" sz="20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2604" y="332656"/>
            <a:ext cx="45896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) PET B (all </a:t>
            </a:r>
            <a:r>
              <a:rPr lang="de-DE" sz="1400" dirty="0" err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atients</a:t>
            </a:r>
            <a:r>
              <a:rPr lang="de-DE" sz="1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on </a:t>
            </a:r>
            <a:r>
              <a:rPr lang="de-DE" sz="1400" dirty="0" err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treatment</a:t>
            </a:r>
            <a:r>
              <a:rPr lang="de-DE" sz="1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) vs. </a:t>
            </a:r>
            <a:r>
              <a:rPr lang="de-DE" sz="1400" dirty="0" err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ealthy</a:t>
            </a:r>
            <a:r>
              <a:rPr lang="de-DE" sz="1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ontrols</a:t>
            </a:r>
            <a:endParaRPr lang="de-DE" sz="1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547664" y="4149080"/>
            <a:ext cx="1819948" cy="246221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  0                                     8</a:t>
            </a:r>
            <a:endParaRPr lang="de-DE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41419" y="2256641"/>
            <a:ext cx="5361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B) </a:t>
            </a:r>
            <a:r>
              <a:rPr lang="de-DE" sz="1400" dirty="0" err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ubtraction</a:t>
            </a:r>
            <a:r>
              <a:rPr lang="de-DE" sz="1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nalysis</a:t>
            </a:r>
            <a:r>
              <a:rPr lang="de-DE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(all </a:t>
            </a:r>
            <a:r>
              <a:rPr lang="de-DE" sz="14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atients</a:t>
            </a:r>
            <a:r>
              <a:rPr lang="de-DE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): </a:t>
            </a:r>
            <a:r>
              <a:rPr lang="de-DE" sz="1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ET A vs. PET B</a:t>
            </a:r>
            <a:endParaRPr lang="de-DE" sz="1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6876255" y="4160324"/>
            <a:ext cx="154271" cy="246221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8</a:t>
            </a:r>
            <a:endParaRPr lang="de-DE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2"/>
          <a:srcRect l="71300" t="71368" r="26227" b="20047"/>
          <a:stretch/>
        </p:blipFill>
        <p:spPr>
          <a:xfrm rot="5400000">
            <a:off x="6099274" y="3623332"/>
            <a:ext cx="157829" cy="1296000"/>
          </a:xfrm>
          <a:prstGeom prst="rect">
            <a:avLst/>
          </a:prstGeom>
        </p:spPr>
      </p:pic>
      <p:sp>
        <p:nvSpPr>
          <p:cNvPr id="56" name="Textfeld 55"/>
          <p:cNvSpPr txBox="1"/>
          <p:nvPr/>
        </p:nvSpPr>
        <p:spPr>
          <a:xfrm flipH="1">
            <a:off x="5425843" y="4149080"/>
            <a:ext cx="226277" cy="246221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de-DE" sz="10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0</a:t>
            </a:r>
            <a:endParaRPr lang="de-DE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60" name="Grafik 59"/>
          <p:cNvPicPr>
            <a:picLocks noChangeAspect="1"/>
          </p:cNvPicPr>
          <p:nvPr/>
        </p:nvPicPr>
        <p:blipFill rotWithShape="1">
          <a:blip r:embed="rId3"/>
          <a:srcRect l="60346" t="71426" r="36536" b="21388"/>
          <a:stretch/>
        </p:blipFill>
        <p:spPr>
          <a:xfrm rot="5400000">
            <a:off x="2407292" y="3737252"/>
            <a:ext cx="159544" cy="1069877"/>
          </a:xfrm>
          <a:prstGeom prst="rect">
            <a:avLst/>
          </a:prstGeom>
        </p:spPr>
      </p:pic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2"/>
          <a:srcRect l="44957" t="42934" r="43821" b="47882"/>
          <a:stretch/>
        </p:blipFill>
        <p:spPr>
          <a:xfrm>
            <a:off x="6572282" y="730778"/>
            <a:ext cx="1048564" cy="1235808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2"/>
          <a:srcRect l="34040" t="15441" r="54458" b="75365"/>
          <a:stretch/>
        </p:blipFill>
        <p:spPr>
          <a:xfrm>
            <a:off x="329917" y="741358"/>
            <a:ext cx="1076261" cy="1238953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 rotWithShape="1">
          <a:blip r:embed="rId2"/>
          <a:srcRect l="56328" t="24624" r="32571" b="66090"/>
          <a:stretch/>
        </p:blipFill>
        <p:spPr>
          <a:xfrm>
            <a:off x="3506617" y="721734"/>
            <a:ext cx="1044974" cy="1259005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2"/>
          <a:srcRect l="34486" t="33684" r="54547" b="57122"/>
          <a:stretch/>
        </p:blipFill>
        <p:spPr>
          <a:xfrm>
            <a:off x="4552011" y="680615"/>
            <a:ext cx="1054907" cy="1273605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2"/>
          <a:srcRect l="67039" t="15508" r="21596" b="75248"/>
          <a:stretch/>
        </p:blipFill>
        <p:spPr>
          <a:xfrm>
            <a:off x="1393809" y="685009"/>
            <a:ext cx="1085229" cy="1271269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2"/>
          <a:srcRect l="33973" t="52131" r="54845" b="38810"/>
          <a:stretch/>
        </p:blipFill>
        <p:spPr>
          <a:xfrm>
            <a:off x="7561032" y="691034"/>
            <a:ext cx="1093328" cy="1275552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2"/>
          <a:srcRect l="23896" t="24717" r="65671" b="66182"/>
          <a:stretch/>
        </p:blipFill>
        <p:spPr>
          <a:xfrm>
            <a:off x="2503524" y="700246"/>
            <a:ext cx="1007902" cy="1266340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 rotWithShape="1">
          <a:blip r:embed="rId2"/>
          <a:srcRect l="1416" t="42896" r="87483" b="47910"/>
          <a:stretch/>
        </p:blipFill>
        <p:spPr>
          <a:xfrm>
            <a:off x="5591332" y="726133"/>
            <a:ext cx="1040764" cy="1241394"/>
          </a:xfrm>
          <a:prstGeom prst="rect">
            <a:avLst/>
          </a:prstGeom>
        </p:spPr>
      </p:pic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4"/>
          <a:srcRect l="67236" t="15918" r="22228" b="75168"/>
          <a:stretch/>
        </p:blipFill>
        <p:spPr>
          <a:xfrm>
            <a:off x="1406178" y="2660762"/>
            <a:ext cx="1043587" cy="1259941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4"/>
          <a:srcRect l="34658" t="34241" r="55183" b="56658"/>
          <a:stretch/>
        </p:blipFill>
        <p:spPr>
          <a:xfrm>
            <a:off x="4676756" y="2587627"/>
            <a:ext cx="1024837" cy="1310230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4"/>
          <a:srcRect l="23509" t="24782" r="65946" b="65936"/>
          <a:stretch/>
        </p:blipFill>
        <p:spPr>
          <a:xfrm>
            <a:off x="2487064" y="2609138"/>
            <a:ext cx="1033615" cy="1298321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4"/>
          <a:srcRect l="1563" t="34204" r="87634" b="56695"/>
          <a:stretch/>
        </p:blipFill>
        <p:spPr>
          <a:xfrm>
            <a:off x="3539326" y="2617592"/>
            <a:ext cx="1092065" cy="1313076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4"/>
          <a:srcRect l="23509" t="52633" r="66332" b="38355"/>
          <a:stretch/>
        </p:blipFill>
        <p:spPr>
          <a:xfrm>
            <a:off x="7694588" y="2609138"/>
            <a:ext cx="969354" cy="1227031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4"/>
          <a:srcRect l="34281" t="15664" r="54659" b="74964"/>
          <a:stretch/>
        </p:blipFill>
        <p:spPr>
          <a:xfrm>
            <a:off x="395288" y="2664889"/>
            <a:ext cx="1020423" cy="1234000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4"/>
          <a:srcRect l="45138" t="43239" r="44060" b="47569"/>
          <a:stretch/>
        </p:blipFill>
        <p:spPr>
          <a:xfrm>
            <a:off x="6698230" y="2627485"/>
            <a:ext cx="1006827" cy="1222576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4"/>
          <a:srcRect l="1543" t="43330" r="87783" b="47658"/>
          <a:stretch/>
        </p:blipFill>
        <p:spPr>
          <a:xfrm>
            <a:off x="5739345" y="2625258"/>
            <a:ext cx="1018433" cy="1227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57477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bense</dc:creator>
  <cp:lastModifiedBy>Becker-Bense, Sandra Prof. Dr.med.</cp:lastModifiedBy>
  <cp:revision>78</cp:revision>
  <cp:lastPrinted>2022-05-17T09:48:34Z</cp:lastPrinted>
  <dcterms:created xsi:type="dcterms:W3CDTF">2013-09-05T08:18:21Z</dcterms:created>
  <dcterms:modified xsi:type="dcterms:W3CDTF">2022-05-20T08:42:01Z</dcterms:modified>
</cp:coreProperties>
</file>